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77"/>
  </p:normalViewPr>
  <p:slideViewPr>
    <p:cSldViewPr snapToGrid="0">
      <p:cViewPr varScale="1">
        <p:scale>
          <a:sx n="87" d="100"/>
          <a:sy n="87" d="100"/>
        </p:scale>
        <p:origin x="100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A36F6CD-2E2F-E68B-8486-3B7DBE3127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0614860-73D9-9BF1-4BCD-0424BDE438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MX"/>
              <a:t>Haz clic para edit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B4C62E5-178C-9179-793A-45EAB70BD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E64BE14-85C2-C34D-5E5A-55481B4DB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E68B51D-34CF-7D6B-5FC5-6DEE77E0C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583984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41113C-37A9-BDA4-DE79-A814FCCF09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A6D2BAD-5316-BBE6-4BCA-1D5DC440A4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1183D3F-3CA6-6C9D-7623-143605E22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062607C-EEC1-CDEC-E82F-9BC5D806D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4970A48-F845-F1A4-1B8C-EC98A7C40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29531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8E5178A-2EAA-4C3E-2EDF-29D69A7E7E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17CA30F-4408-08FA-79FA-2EA685EBFA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A349A37-1F33-3E6C-A51F-91941CD18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D958DFB-7093-C6DF-4464-BD447ACA0B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EC999CD-BD2F-ECA5-5B32-07429CFE6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749742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5349048-D7D0-8B36-204C-B0343E7247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D57C099-C748-586D-DEDA-A239D1CF4C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440E5DE-0FD0-3DE3-B219-6FFBEB8C1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31EFE8A-05CB-EC57-A41A-3F79BB7C3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71E09E4-83B7-1F29-6147-1BD7B7F57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8492143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D6372F3-2368-84AB-DDBB-8A74C74F90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346B106-F1F9-9DBC-43CB-C0A788EBBF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454B66B-DDF9-EB11-C3C2-9D317CE9EE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6B7C31C-1E48-5DFE-0958-C3C47C2AF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1ED8DC2-B1E5-986D-A356-3F52BAF24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676812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F0CBC4-DD61-8882-9FD3-28664EBDB0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B77D84A-F13F-4F6F-0B1F-46F3F9BF6D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CD66C32-6081-0506-8CFD-172384D297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750110F-EAA5-011B-F98E-AFB6984BE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36D106C-5126-BEB3-F661-39162C14E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31D0CCB-7DDC-FA86-95CC-B6CA83408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78294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12111B3-4002-606A-9388-8C9671184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AAD80F1-892A-21B2-E3E6-5F1A54CA45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902D3D3-6664-C678-CDEC-0CBA2384F3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E3FC0745-4318-2435-C3FA-A16277A837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754AF71E-98DA-4752-EA9F-7C22AF306B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356222F-E345-46AB-CF43-FDFF38C94A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66D81E8C-1383-848D-974E-3D16382C1A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6D35029-5E46-35B1-9ADF-0CCC7D9E6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585799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7175A8A-4AD8-B177-DF49-9866F6ADEC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DC0366E1-CA10-FEA3-A437-ACB9049B61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993049B-B473-0210-7CED-006BE7FA5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6E1D5031-C3C4-89EF-2FD7-EEE3243D3A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184802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97210C9E-3E1F-55F9-4014-84982E037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6CB91448-7FD9-4195-C4C7-59F0FE7814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98EC59F-1E60-E634-1976-55D3CA057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74680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D37D0A1-7325-F97C-475A-8E4F00698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28776CB-7F3F-51C9-19DC-CB519BF05D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FA62D40-20EF-C576-C5B4-CD109F2A4C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6095BB6-7417-B46F-956C-D57C6356B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BF960B2-5621-F55A-4AB4-DD9EAF999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6527F71-AF5E-E899-CBC3-3AA995BF5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308458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EE7CF1-648F-E05F-A0A7-633784C86B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ECABA4E3-7CD5-4E9C-2BF9-A2D2A7240C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5B18442-9DA7-F3FE-24EC-9839657D9C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B6253E6-E4D7-2190-0CCC-3B54D4522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CDA7C14-D998-E4B6-3A76-47F1C55C7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0C526CC-2A21-E94F-5D0C-1F93DEE6F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985214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1CD99FA0-A374-B60C-CEB6-833B35602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1AD3899-20D3-7FD6-7EF1-268D5AE376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48FFAB1-4C0B-87D5-FB3F-D773F214A1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6475FB-50E8-C647-B119-BF1445D560E6}" type="datetimeFigureOut">
              <a:rPr lang="es-CO" smtClean="0"/>
              <a:t>18/09/25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5CD9E65-F318-4925-A8C4-D4E0F8E2AB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86EED57-D240-FE1F-0E22-F731CE6645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E63A14-CFC9-3A4B-A086-1B169A8D364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45854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g"/><Relationship Id="rId5" Type="http://schemas.openxmlformats.org/officeDocument/2006/relationships/image" Target="../media/image13.jpg"/><Relationship Id="rId4" Type="http://schemas.openxmlformats.org/officeDocument/2006/relationships/image" Target="../media/image12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jpg"/><Relationship Id="rId4" Type="http://schemas.openxmlformats.org/officeDocument/2006/relationships/image" Target="../media/image16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jpg"/><Relationship Id="rId4" Type="http://schemas.openxmlformats.org/officeDocument/2006/relationships/image" Target="../media/image18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jpg"/><Relationship Id="rId4" Type="http://schemas.openxmlformats.org/officeDocument/2006/relationships/image" Target="../media/image2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4CDD7C1E-830D-49F7-2D24-241519554BF9}"/>
              </a:ext>
            </a:extLst>
          </p:cNvPr>
          <p:cNvSpPr txBox="1"/>
          <p:nvPr/>
        </p:nvSpPr>
        <p:spPr>
          <a:xfrm>
            <a:off x="409268" y="397895"/>
            <a:ext cx="609845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O" sz="2800" dirty="0" err="1"/>
              <a:t>Supplementary</a:t>
            </a:r>
            <a:r>
              <a:rPr lang="es-CO" sz="2800" dirty="0"/>
              <a:t> material Figures</a:t>
            </a:r>
          </a:p>
        </p:txBody>
      </p:sp>
    </p:spTree>
    <p:extLst>
      <p:ext uri="{BB962C8B-B14F-4D97-AF65-F5344CB8AC3E}">
        <p14:creationId xmlns:p14="http://schemas.microsoft.com/office/powerpoint/2010/main" val="39418295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5">
            <a:extLst>
              <a:ext uri="{FF2B5EF4-FFF2-40B4-BE49-F238E27FC236}">
                <a16:creationId xmlns:a16="http://schemas.microsoft.com/office/drawing/2014/main" id="{243DBCA1-F32C-9F18-6310-104EF0226E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542" y="577655"/>
            <a:ext cx="2859435" cy="5842460"/>
          </a:xfrm>
          <a:prstGeom prst="rect">
            <a:avLst/>
          </a:prstGeom>
        </p:spPr>
      </p:pic>
      <p:pic>
        <p:nvPicPr>
          <p:cNvPr id="5" name="図 5">
            <a:extLst>
              <a:ext uri="{FF2B5EF4-FFF2-40B4-BE49-F238E27FC236}">
                <a16:creationId xmlns:a16="http://schemas.microsoft.com/office/drawing/2014/main" id="{2D92C311-B068-4401-29C0-9BD0BD923C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5195" y="577657"/>
            <a:ext cx="2859435" cy="584246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CD45BC83-B859-36F2-BDB1-C77C751068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0137" y="602720"/>
            <a:ext cx="2859435" cy="5842460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810F3AF0-DBFD-9DF7-7E4C-A00F18089D9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047" y="1338734"/>
            <a:ext cx="2475846" cy="442579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85AFD02C-21EA-1CB7-E5D8-6687B51C970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85" b="14567"/>
          <a:stretch/>
        </p:blipFill>
        <p:spPr>
          <a:xfrm>
            <a:off x="3410094" y="1342859"/>
            <a:ext cx="2504452" cy="4414193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9" name="図 5">
            <a:extLst>
              <a:ext uri="{FF2B5EF4-FFF2-40B4-BE49-F238E27FC236}">
                <a16:creationId xmlns:a16="http://schemas.microsoft.com/office/drawing/2014/main" id="{316C27E9-72BF-5ADD-E1F6-21FC05A586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1357" y="623782"/>
            <a:ext cx="2859435" cy="5842460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599C249C-46C5-EE26-D690-9C89BB4C998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57" b="13120"/>
          <a:stretch/>
        </p:blipFill>
        <p:spPr>
          <a:xfrm>
            <a:off x="6397530" y="1356408"/>
            <a:ext cx="2461606" cy="4390703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E468E03A-6BF5-4A0B-F9F3-FE23887C26D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57" b="12867"/>
          <a:stretch/>
        </p:blipFill>
        <p:spPr>
          <a:xfrm>
            <a:off x="9342958" y="1362654"/>
            <a:ext cx="2469934" cy="441909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id="{0E521AFF-1CB4-58D5-1A7B-8CCB72BF4F3F}"/>
              </a:ext>
            </a:extLst>
          </p:cNvPr>
          <p:cNvSpPr/>
          <p:nvPr/>
        </p:nvSpPr>
        <p:spPr>
          <a:xfrm>
            <a:off x="452047" y="1356409"/>
            <a:ext cx="2460314" cy="151757"/>
          </a:xfrm>
          <a:prstGeom prst="rect">
            <a:avLst/>
          </a:prstGeom>
          <a:solidFill>
            <a:srgbClr val="13C3B3"/>
          </a:solidFill>
          <a:ln>
            <a:solidFill>
              <a:srgbClr val="13C3B3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33AFBABC-9303-2041-A537-4D7256114A10}"/>
              </a:ext>
            </a:extLst>
          </p:cNvPr>
          <p:cNvSpPr txBox="1"/>
          <p:nvPr/>
        </p:nvSpPr>
        <p:spPr>
          <a:xfrm>
            <a:off x="205053" y="85405"/>
            <a:ext cx="3850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 err="1"/>
              <a:t>Supplementary</a:t>
            </a:r>
            <a:r>
              <a:rPr lang="es-CO" dirty="0"/>
              <a:t> material Figure 1S</a:t>
            </a:r>
          </a:p>
        </p:txBody>
      </p:sp>
    </p:spTree>
    <p:extLst>
      <p:ext uri="{BB962C8B-B14F-4D97-AF65-F5344CB8AC3E}">
        <p14:creationId xmlns:p14="http://schemas.microsoft.com/office/powerpoint/2010/main" val="3877622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5">
            <a:extLst>
              <a:ext uri="{FF2B5EF4-FFF2-40B4-BE49-F238E27FC236}">
                <a16:creationId xmlns:a16="http://schemas.microsoft.com/office/drawing/2014/main" id="{CC3072E0-0A51-B811-9504-0D354BD341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313" y="593765"/>
            <a:ext cx="2851550" cy="5826349"/>
          </a:xfrm>
          <a:prstGeom prst="rect">
            <a:avLst/>
          </a:prstGeom>
        </p:spPr>
      </p:pic>
      <p:pic>
        <p:nvPicPr>
          <p:cNvPr id="3" name="図 5">
            <a:extLst>
              <a:ext uri="{FF2B5EF4-FFF2-40B4-BE49-F238E27FC236}">
                <a16:creationId xmlns:a16="http://schemas.microsoft.com/office/drawing/2014/main" id="{004C03B9-423E-CF44-0CF5-087627CC35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4575" y="593767"/>
            <a:ext cx="2851550" cy="5826349"/>
          </a:xfrm>
          <a:prstGeom prst="rect">
            <a:avLst/>
          </a:prstGeom>
        </p:spPr>
      </p:pic>
      <p:pic>
        <p:nvPicPr>
          <p:cNvPr id="12" name="図 5">
            <a:extLst>
              <a:ext uri="{FF2B5EF4-FFF2-40B4-BE49-F238E27FC236}">
                <a16:creationId xmlns:a16="http://schemas.microsoft.com/office/drawing/2014/main" id="{7E6F81CA-906F-8C0C-34D1-BD5D5077D4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3254" y="618830"/>
            <a:ext cx="2851550" cy="5826349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1F46F655-6DCF-D92D-6614-3F206907A61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011" y="1350873"/>
            <a:ext cx="2469018" cy="441359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5" name="図 5">
            <a:extLst>
              <a:ext uri="{FF2B5EF4-FFF2-40B4-BE49-F238E27FC236}">
                <a16:creationId xmlns:a16="http://schemas.microsoft.com/office/drawing/2014/main" id="{02A71019-CEB7-893D-B5D1-BF412A4734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4224" y="639892"/>
            <a:ext cx="2851550" cy="5826349"/>
          </a:xfrm>
          <a:prstGeom prst="rect">
            <a:avLst/>
          </a:prstGeom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8A8A5556-8B0C-5CE8-6463-4736CFDA84C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45" b="12472"/>
          <a:stretch/>
        </p:blipFill>
        <p:spPr>
          <a:xfrm>
            <a:off x="3472375" y="1350874"/>
            <a:ext cx="2451836" cy="441359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7" name="Imagen 16">
            <a:extLst>
              <a:ext uri="{FF2B5EF4-FFF2-40B4-BE49-F238E27FC236}">
                <a16:creationId xmlns:a16="http://schemas.microsoft.com/office/drawing/2014/main" id="{5E84DBEF-524D-9B40-1FBF-6A67A4EFA5D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87" b="13753"/>
          <a:stretch/>
        </p:blipFill>
        <p:spPr>
          <a:xfrm>
            <a:off x="6410358" y="1370682"/>
            <a:ext cx="2494554" cy="441359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EE6A4EEC-8B15-2165-FCBD-84CC5FA0875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31" b="11971"/>
          <a:stretch/>
        </p:blipFill>
        <p:spPr>
          <a:xfrm>
            <a:off x="9384773" y="1392295"/>
            <a:ext cx="2445503" cy="441359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9" name="Rectángulo 18">
            <a:extLst>
              <a:ext uri="{FF2B5EF4-FFF2-40B4-BE49-F238E27FC236}">
                <a16:creationId xmlns:a16="http://schemas.microsoft.com/office/drawing/2014/main" id="{D61A1597-68F6-DE28-CD61-44EFA3A725BA}"/>
              </a:ext>
            </a:extLst>
          </p:cNvPr>
          <p:cNvSpPr/>
          <p:nvPr/>
        </p:nvSpPr>
        <p:spPr>
          <a:xfrm>
            <a:off x="562226" y="1382505"/>
            <a:ext cx="2330470" cy="214587"/>
          </a:xfrm>
          <a:prstGeom prst="rect">
            <a:avLst/>
          </a:prstGeom>
          <a:solidFill>
            <a:srgbClr val="13C3B3"/>
          </a:solidFill>
          <a:ln>
            <a:solidFill>
              <a:srgbClr val="13C3B3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21" name="Rectángulo 20">
            <a:extLst>
              <a:ext uri="{FF2B5EF4-FFF2-40B4-BE49-F238E27FC236}">
                <a16:creationId xmlns:a16="http://schemas.microsoft.com/office/drawing/2014/main" id="{5562AF01-0541-D67E-5FFE-54CD28CD7382}"/>
              </a:ext>
            </a:extLst>
          </p:cNvPr>
          <p:cNvSpPr/>
          <p:nvPr/>
        </p:nvSpPr>
        <p:spPr>
          <a:xfrm>
            <a:off x="9430768" y="1400177"/>
            <a:ext cx="2358462" cy="178701"/>
          </a:xfrm>
          <a:prstGeom prst="rect">
            <a:avLst/>
          </a:prstGeom>
          <a:solidFill>
            <a:srgbClr val="13C3B3"/>
          </a:solidFill>
          <a:ln>
            <a:solidFill>
              <a:srgbClr val="13C3B3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25" name="Rectángulo 24">
            <a:extLst>
              <a:ext uri="{FF2B5EF4-FFF2-40B4-BE49-F238E27FC236}">
                <a16:creationId xmlns:a16="http://schemas.microsoft.com/office/drawing/2014/main" id="{B510AA69-A04A-09BF-5952-41EB805DDEBB}"/>
              </a:ext>
            </a:extLst>
          </p:cNvPr>
          <p:cNvSpPr/>
          <p:nvPr/>
        </p:nvSpPr>
        <p:spPr>
          <a:xfrm>
            <a:off x="6407183" y="1370682"/>
            <a:ext cx="2494554" cy="270790"/>
          </a:xfrm>
          <a:prstGeom prst="rect">
            <a:avLst/>
          </a:prstGeom>
          <a:solidFill>
            <a:srgbClr val="035373"/>
          </a:solidFill>
          <a:ln w="19050" cap="flat" cmpd="sng" algn="ctr">
            <a:solidFill>
              <a:srgbClr val="03537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CO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26" name="Rectángulo 25">
            <a:extLst>
              <a:ext uri="{FF2B5EF4-FFF2-40B4-BE49-F238E27FC236}">
                <a16:creationId xmlns:a16="http://schemas.microsoft.com/office/drawing/2014/main" id="{FE24C8FA-BBE7-8F02-C623-98373E1ADB7C}"/>
              </a:ext>
            </a:extLst>
          </p:cNvPr>
          <p:cNvSpPr/>
          <p:nvPr/>
        </p:nvSpPr>
        <p:spPr>
          <a:xfrm>
            <a:off x="3515324" y="1378057"/>
            <a:ext cx="2330470" cy="214587"/>
          </a:xfrm>
          <a:prstGeom prst="rect">
            <a:avLst/>
          </a:prstGeom>
          <a:solidFill>
            <a:srgbClr val="13C3B3"/>
          </a:solidFill>
          <a:ln>
            <a:solidFill>
              <a:srgbClr val="13C3B3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2166D2FF-203B-644D-9EE8-E0FB15F6665D}"/>
              </a:ext>
            </a:extLst>
          </p:cNvPr>
          <p:cNvSpPr txBox="1"/>
          <p:nvPr/>
        </p:nvSpPr>
        <p:spPr>
          <a:xfrm>
            <a:off x="286313" y="68554"/>
            <a:ext cx="4484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 err="1"/>
              <a:t>Supplementary</a:t>
            </a:r>
            <a:r>
              <a:rPr lang="es-CO" dirty="0"/>
              <a:t> material Figure 2S</a:t>
            </a:r>
          </a:p>
        </p:txBody>
      </p:sp>
    </p:spTree>
    <p:extLst>
      <p:ext uri="{BB962C8B-B14F-4D97-AF65-F5344CB8AC3E}">
        <p14:creationId xmlns:p14="http://schemas.microsoft.com/office/powerpoint/2010/main" val="23785744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5">
            <a:extLst>
              <a:ext uri="{FF2B5EF4-FFF2-40B4-BE49-F238E27FC236}">
                <a16:creationId xmlns:a16="http://schemas.microsoft.com/office/drawing/2014/main" id="{3E9912EE-42DC-B3FF-6854-31D361286C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0233" y="377289"/>
            <a:ext cx="3043863" cy="6219288"/>
          </a:xfrm>
          <a:prstGeom prst="rect">
            <a:avLst/>
          </a:prstGeom>
        </p:spPr>
      </p:pic>
      <p:pic>
        <p:nvPicPr>
          <p:cNvPr id="5" name="図 5">
            <a:extLst>
              <a:ext uri="{FF2B5EF4-FFF2-40B4-BE49-F238E27FC236}">
                <a16:creationId xmlns:a16="http://schemas.microsoft.com/office/drawing/2014/main" id="{9688E8E0-C38D-2B55-7AB3-0199D43758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8875" y="377291"/>
            <a:ext cx="3043863" cy="6219288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B11A2580-C2F9-7B0C-AC20-268AA236A7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4421" y="402354"/>
            <a:ext cx="3043863" cy="6219288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A56B5AAB-506C-A901-BFAC-6EC85FC6762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6227" y="1185130"/>
            <a:ext cx="2635533" cy="471125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05D6618B-77E0-A8AF-019A-74B954264A6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82" t="5403" r="282" b="11540"/>
          <a:stretch/>
        </p:blipFill>
        <p:spPr>
          <a:xfrm>
            <a:off x="4422556" y="1185132"/>
            <a:ext cx="2617995" cy="471124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BB5ABFA4-1C61-3ADE-8932-A6A2A49F056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45" b="13409"/>
          <a:stretch/>
        </p:blipFill>
        <p:spPr>
          <a:xfrm>
            <a:off x="7803436" y="1185131"/>
            <a:ext cx="2646990" cy="471125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0" name="Rectángulo 9">
            <a:extLst>
              <a:ext uri="{FF2B5EF4-FFF2-40B4-BE49-F238E27FC236}">
                <a16:creationId xmlns:a16="http://schemas.microsoft.com/office/drawing/2014/main" id="{28909130-7AB3-A475-501E-31CDD41B79D8}"/>
              </a:ext>
            </a:extLst>
          </p:cNvPr>
          <p:cNvSpPr/>
          <p:nvPr/>
        </p:nvSpPr>
        <p:spPr>
          <a:xfrm>
            <a:off x="1066113" y="1199959"/>
            <a:ext cx="2542061" cy="192931"/>
          </a:xfrm>
          <a:prstGeom prst="rect">
            <a:avLst/>
          </a:prstGeom>
          <a:solidFill>
            <a:srgbClr val="13C3B3"/>
          </a:solidFill>
          <a:ln>
            <a:solidFill>
              <a:srgbClr val="13C3B3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759C72C7-7A41-5F7E-3D53-3839606BFD4C}"/>
              </a:ext>
            </a:extLst>
          </p:cNvPr>
          <p:cNvSpPr txBox="1"/>
          <p:nvPr/>
        </p:nvSpPr>
        <p:spPr>
          <a:xfrm>
            <a:off x="57714" y="-60654"/>
            <a:ext cx="4484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 err="1"/>
              <a:t>Supplementary</a:t>
            </a:r>
            <a:r>
              <a:rPr lang="es-CO" dirty="0"/>
              <a:t> material Figure 3S</a:t>
            </a:r>
          </a:p>
        </p:txBody>
      </p:sp>
    </p:spTree>
    <p:extLst>
      <p:ext uri="{BB962C8B-B14F-4D97-AF65-F5344CB8AC3E}">
        <p14:creationId xmlns:p14="http://schemas.microsoft.com/office/powerpoint/2010/main" val="22805753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5">
            <a:extLst>
              <a:ext uri="{FF2B5EF4-FFF2-40B4-BE49-F238E27FC236}">
                <a16:creationId xmlns:a16="http://schemas.microsoft.com/office/drawing/2014/main" id="{95E0D858-DF57-C891-793D-D484DF08B7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4309" y="372140"/>
            <a:ext cx="3034606" cy="6200374"/>
          </a:xfrm>
          <a:prstGeom prst="rect">
            <a:avLst/>
          </a:prstGeom>
        </p:spPr>
      </p:pic>
      <p:pic>
        <p:nvPicPr>
          <p:cNvPr id="3" name="図 5">
            <a:extLst>
              <a:ext uri="{FF2B5EF4-FFF2-40B4-BE49-F238E27FC236}">
                <a16:creationId xmlns:a16="http://schemas.microsoft.com/office/drawing/2014/main" id="{070425D0-7042-85B5-607B-B57C49859D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5606" y="372142"/>
            <a:ext cx="3034606" cy="6200374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EAF54F14-C3CE-426E-40D6-FAACE74CF7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5022" y="1158100"/>
            <a:ext cx="2627518" cy="4696923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BB0443E5-1615-E0F0-311E-CD47F4BEC53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95" b="15897"/>
          <a:stretch/>
        </p:blipFill>
        <p:spPr>
          <a:xfrm>
            <a:off x="5638032" y="1158101"/>
            <a:ext cx="2649877" cy="469692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3" name="Rectángulo 12">
            <a:extLst>
              <a:ext uri="{FF2B5EF4-FFF2-40B4-BE49-F238E27FC236}">
                <a16:creationId xmlns:a16="http://schemas.microsoft.com/office/drawing/2014/main" id="{9B6E6477-C4D9-4A3E-C229-D72B7BE7C689}"/>
              </a:ext>
            </a:extLst>
          </p:cNvPr>
          <p:cNvSpPr/>
          <p:nvPr/>
        </p:nvSpPr>
        <p:spPr>
          <a:xfrm>
            <a:off x="2208397" y="1210653"/>
            <a:ext cx="2542061" cy="192931"/>
          </a:xfrm>
          <a:prstGeom prst="rect">
            <a:avLst/>
          </a:prstGeom>
          <a:solidFill>
            <a:srgbClr val="13C3B3"/>
          </a:solidFill>
          <a:ln>
            <a:solidFill>
              <a:srgbClr val="13C3B3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05D021B8-3CD0-1507-8D7B-A6D00043B91C}"/>
              </a:ext>
            </a:extLst>
          </p:cNvPr>
          <p:cNvSpPr txBox="1"/>
          <p:nvPr/>
        </p:nvSpPr>
        <p:spPr>
          <a:xfrm>
            <a:off x="286313" y="68554"/>
            <a:ext cx="4484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 err="1"/>
              <a:t>Supplementary</a:t>
            </a:r>
            <a:r>
              <a:rPr lang="es-CO" dirty="0"/>
              <a:t> material Figure 4S</a:t>
            </a:r>
          </a:p>
        </p:txBody>
      </p:sp>
    </p:spTree>
    <p:extLst>
      <p:ext uri="{BB962C8B-B14F-4D97-AF65-F5344CB8AC3E}">
        <p14:creationId xmlns:p14="http://schemas.microsoft.com/office/powerpoint/2010/main" val="15182792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5">
            <a:extLst>
              <a:ext uri="{FF2B5EF4-FFF2-40B4-BE49-F238E27FC236}">
                <a16:creationId xmlns:a16="http://schemas.microsoft.com/office/drawing/2014/main" id="{15585749-922E-890F-56F3-215B842A80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001" y="893673"/>
            <a:ext cx="2704768" cy="5526442"/>
          </a:xfrm>
          <a:prstGeom prst="rect">
            <a:avLst/>
          </a:prstGeom>
        </p:spPr>
      </p:pic>
      <p:pic>
        <p:nvPicPr>
          <p:cNvPr id="5" name="図 5">
            <a:extLst>
              <a:ext uri="{FF2B5EF4-FFF2-40B4-BE49-F238E27FC236}">
                <a16:creationId xmlns:a16="http://schemas.microsoft.com/office/drawing/2014/main" id="{8EFE19E3-25AA-F1B5-CC60-F24233DE8E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8627" y="893675"/>
            <a:ext cx="2704768" cy="5526442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036A2769-4F29-06B7-BC66-7CFB6BBDB6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1173" y="918738"/>
            <a:ext cx="2704768" cy="5526442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AA49DB75-F2FB-DE08-DEF3-792EA8854E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293" y="1617828"/>
            <a:ext cx="2341928" cy="418640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8" name="図 5">
            <a:extLst>
              <a:ext uri="{FF2B5EF4-FFF2-40B4-BE49-F238E27FC236}">
                <a16:creationId xmlns:a16="http://schemas.microsoft.com/office/drawing/2014/main" id="{9E38291F-6FD1-A1DA-B159-697E703392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1654" y="939800"/>
            <a:ext cx="2704768" cy="5526442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7DDA2016-464F-ABBE-6577-B606A85C0B4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88" b="12118"/>
          <a:stretch/>
        </p:blipFill>
        <p:spPr>
          <a:xfrm>
            <a:off x="3324126" y="1597202"/>
            <a:ext cx="2310691" cy="41701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DF17FB96-E3D3-F5C1-5BAB-43B09570358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88" b="13881"/>
          <a:stretch/>
        </p:blipFill>
        <p:spPr>
          <a:xfrm>
            <a:off x="9100668" y="1660531"/>
            <a:ext cx="2317783" cy="4106834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id="{1C755F9F-54C2-B5FE-0022-CAEA97B7F03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44" b="12454"/>
          <a:stretch/>
        </p:blipFill>
        <p:spPr>
          <a:xfrm>
            <a:off x="6206213" y="1634073"/>
            <a:ext cx="2332947" cy="417016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5" name="Rectángulo 14">
            <a:extLst>
              <a:ext uri="{FF2B5EF4-FFF2-40B4-BE49-F238E27FC236}">
                <a16:creationId xmlns:a16="http://schemas.microsoft.com/office/drawing/2014/main" id="{E88B45F5-CBCC-259D-47DB-14F897C33D7E}"/>
              </a:ext>
            </a:extLst>
          </p:cNvPr>
          <p:cNvSpPr/>
          <p:nvPr/>
        </p:nvSpPr>
        <p:spPr>
          <a:xfrm>
            <a:off x="504565" y="1634073"/>
            <a:ext cx="2231262" cy="192931"/>
          </a:xfrm>
          <a:prstGeom prst="rect">
            <a:avLst/>
          </a:prstGeom>
          <a:solidFill>
            <a:srgbClr val="13C3B3"/>
          </a:solidFill>
          <a:ln>
            <a:solidFill>
              <a:srgbClr val="13C3B3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C9010701-2874-E9EE-77BA-BCE563EEF83D}"/>
              </a:ext>
            </a:extLst>
          </p:cNvPr>
          <p:cNvSpPr txBox="1"/>
          <p:nvPr/>
        </p:nvSpPr>
        <p:spPr>
          <a:xfrm>
            <a:off x="286313" y="68554"/>
            <a:ext cx="4484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 err="1"/>
              <a:t>Supplementary</a:t>
            </a:r>
            <a:r>
              <a:rPr lang="es-CO" dirty="0"/>
              <a:t> material Figure 5S</a:t>
            </a:r>
          </a:p>
        </p:txBody>
      </p:sp>
    </p:spTree>
    <p:extLst>
      <p:ext uri="{BB962C8B-B14F-4D97-AF65-F5344CB8AC3E}">
        <p14:creationId xmlns:p14="http://schemas.microsoft.com/office/powerpoint/2010/main" val="11239528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5">
            <a:extLst>
              <a:ext uri="{FF2B5EF4-FFF2-40B4-BE49-F238E27FC236}">
                <a16:creationId xmlns:a16="http://schemas.microsoft.com/office/drawing/2014/main" id="{577CA2D6-FC49-722F-54DD-AA96452744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193" y="406207"/>
            <a:ext cx="3085323" cy="6304000"/>
          </a:xfrm>
          <a:prstGeom prst="rect">
            <a:avLst/>
          </a:prstGeom>
        </p:spPr>
      </p:pic>
      <p:pic>
        <p:nvPicPr>
          <p:cNvPr id="3" name="図 5">
            <a:extLst>
              <a:ext uri="{FF2B5EF4-FFF2-40B4-BE49-F238E27FC236}">
                <a16:creationId xmlns:a16="http://schemas.microsoft.com/office/drawing/2014/main" id="{2490C5C8-BB01-F3CE-9AB2-32E7449EC9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8044" y="406209"/>
            <a:ext cx="3085323" cy="6304000"/>
          </a:xfrm>
          <a:prstGeom prst="rect">
            <a:avLst/>
          </a:prstGeom>
        </p:spPr>
      </p:pic>
      <p:pic>
        <p:nvPicPr>
          <p:cNvPr id="11" name="図 5">
            <a:extLst>
              <a:ext uri="{FF2B5EF4-FFF2-40B4-BE49-F238E27FC236}">
                <a16:creationId xmlns:a16="http://schemas.microsoft.com/office/drawing/2014/main" id="{D19554D0-89DB-AEDB-07EE-973915C295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880" y="431272"/>
            <a:ext cx="3085323" cy="6304000"/>
          </a:xfrm>
          <a:prstGeom prst="rect">
            <a:avLst/>
          </a:prstGeom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6B360DC2-FF37-C1D8-A415-194441FE0F0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6680" y="1205682"/>
            <a:ext cx="2683515" cy="479702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09174AC9-EECF-99CD-F049-29FF139D279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45" b="11980"/>
          <a:stretch/>
        </p:blipFill>
        <p:spPr>
          <a:xfrm>
            <a:off x="7843507" y="1250108"/>
            <a:ext cx="2649105" cy="479702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63BF4C01-FD10-854A-F87B-DA53520C7EC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31" b="12832"/>
          <a:stretch/>
        </p:blipFill>
        <p:spPr>
          <a:xfrm>
            <a:off x="4510937" y="1218410"/>
            <a:ext cx="2662421" cy="475544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30A1AA99-20BE-0942-FE7B-C7C01CCFEF02}"/>
              </a:ext>
            </a:extLst>
          </p:cNvPr>
          <p:cNvSpPr txBox="1"/>
          <p:nvPr/>
        </p:nvSpPr>
        <p:spPr>
          <a:xfrm>
            <a:off x="0" y="-36875"/>
            <a:ext cx="4484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 err="1"/>
              <a:t>Supplementary</a:t>
            </a:r>
            <a:r>
              <a:rPr lang="es-CO" dirty="0"/>
              <a:t> material Figure 6S</a:t>
            </a:r>
          </a:p>
        </p:txBody>
      </p:sp>
    </p:spTree>
    <p:extLst>
      <p:ext uri="{BB962C8B-B14F-4D97-AF65-F5344CB8AC3E}">
        <p14:creationId xmlns:p14="http://schemas.microsoft.com/office/powerpoint/2010/main" val="21807997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5">
            <a:extLst>
              <a:ext uri="{FF2B5EF4-FFF2-40B4-BE49-F238E27FC236}">
                <a16:creationId xmlns:a16="http://schemas.microsoft.com/office/drawing/2014/main" id="{F51D5966-AC36-1FF4-8E57-35CC5B9F0D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6483" y="402955"/>
            <a:ext cx="2998033" cy="6125646"/>
          </a:xfrm>
          <a:prstGeom prst="rect">
            <a:avLst/>
          </a:prstGeom>
        </p:spPr>
      </p:pic>
      <p:pic>
        <p:nvPicPr>
          <p:cNvPr id="5" name="図 5">
            <a:extLst>
              <a:ext uri="{FF2B5EF4-FFF2-40B4-BE49-F238E27FC236}">
                <a16:creationId xmlns:a16="http://schemas.microsoft.com/office/drawing/2014/main" id="{34EBA302-DB42-C648-7910-AC9EDC1D49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7693" y="402957"/>
            <a:ext cx="2998033" cy="6125646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9778983E-C34D-B223-ABED-9AEC4C06E3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6987" y="428020"/>
            <a:ext cx="2998033" cy="6125646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0D179434-809F-7413-A52C-6FBA5004EC6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5777" y="1196995"/>
            <a:ext cx="2607592" cy="466130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0A837810-2363-A4B1-F3DD-E1633602371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31" b="12618"/>
          <a:stretch/>
        </p:blipFill>
        <p:spPr>
          <a:xfrm>
            <a:off x="7803632" y="1222874"/>
            <a:ext cx="2602925" cy="466130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38ECC14D-621A-072B-6A2B-611DCA4C185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45" b="13218"/>
          <a:stretch/>
        </p:blipFill>
        <p:spPr>
          <a:xfrm>
            <a:off x="4521064" y="1196995"/>
            <a:ext cx="2612865" cy="466130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EA05A199-62EA-3020-6F8B-E2A798B430EB}"/>
              </a:ext>
            </a:extLst>
          </p:cNvPr>
          <p:cNvSpPr txBox="1"/>
          <p:nvPr/>
        </p:nvSpPr>
        <p:spPr>
          <a:xfrm>
            <a:off x="286313" y="68554"/>
            <a:ext cx="4484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 err="1"/>
              <a:t>Supplementary</a:t>
            </a:r>
            <a:r>
              <a:rPr lang="es-CO" dirty="0"/>
              <a:t> material Figure 7S</a:t>
            </a:r>
          </a:p>
        </p:txBody>
      </p:sp>
    </p:spTree>
    <p:extLst>
      <p:ext uri="{BB962C8B-B14F-4D97-AF65-F5344CB8AC3E}">
        <p14:creationId xmlns:p14="http://schemas.microsoft.com/office/powerpoint/2010/main" val="32251405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5">
            <a:extLst>
              <a:ext uri="{FF2B5EF4-FFF2-40B4-BE49-F238E27FC236}">
                <a16:creationId xmlns:a16="http://schemas.microsoft.com/office/drawing/2014/main" id="{192AF8C8-9B5C-5871-BD9A-3C011309C8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3786" y="468746"/>
            <a:ext cx="3073614" cy="6280076"/>
          </a:xfrm>
          <a:prstGeom prst="rect">
            <a:avLst/>
          </a:prstGeom>
        </p:spPr>
      </p:pic>
      <p:pic>
        <p:nvPicPr>
          <p:cNvPr id="3" name="図 5">
            <a:extLst>
              <a:ext uri="{FF2B5EF4-FFF2-40B4-BE49-F238E27FC236}">
                <a16:creationId xmlns:a16="http://schemas.microsoft.com/office/drawing/2014/main" id="{FFB1D8CF-AF82-6BF8-022D-E91527EAC9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8258" y="468748"/>
            <a:ext cx="3073614" cy="6280076"/>
          </a:xfrm>
          <a:prstGeom prst="rect">
            <a:avLst/>
          </a:prstGeom>
        </p:spPr>
      </p:pic>
      <p:pic>
        <p:nvPicPr>
          <p:cNvPr id="10" name="図 5">
            <a:extLst>
              <a:ext uri="{FF2B5EF4-FFF2-40B4-BE49-F238E27FC236}">
                <a16:creationId xmlns:a16="http://schemas.microsoft.com/office/drawing/2014/main" id="{2A1AFF84-D93E-C816-73DA-E34F3C3F46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0802" y="493811"/>
            <a:ext cx="3073614" cy="6280076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46B6BE58-7890-AE3D-9C8C-66478DECA6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3401" y="1294672"/>
            <a:ext cx="2673331" cy="477882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2D5A8EA1-7E7A-0ACD-DBED-8006A3C8E03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11" b="4780"/>
          <a:stretch/>
        </p:blipFill>
        <p:spPr>
          <a:xfrm>
            <a:off x="8008306" y="1303550"/>
            <a:ext cx="2673129" cy="477882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08EFA128-F2D0-136A-A0E2-B7AE87D239B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14" b="11111"/>
          <a:stretch/>
        </p:blipFill>
        <p:spPr>
          <a:xfrm>
            <a:off x="4748452" y="1294672"/>
            <a:ext cx="2598669" cy="477882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A1FA8081-0E5A-4D29-4BB4-775112C4668D}"/>
              </a:ext>
            </a:extLst>
          </p:cNvPr>
          <p:cNvSpPr txBox="1"/>
          <p:nvPr/>
        </p:nvSpPr>
        <p:spPr>
          <a:xfrm>
            <a:off x="33788" y="0"/>
            <a:ext cx="4484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 err="1"/>
              <a:t>Supplementary</a:t>
            </a:r>
            <a:r>
              <a:rPr lang="es-CO" dirty="0"/>
              <a:t> material Figure 8S</a:t>
            </a:r>
          </a:p>
        </p:txBody>
      </p:sp>
    </p:spTree>
    <p:extLst>
      <p:ext uri="{BB962C8B-B14F-4D97-AF65-F5344CB8AC3E}">
        <p14:creationId xmlns:p14="http://schemas.microsoft.com/office/powerpoint/2010/main" val="41426718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</Words>
  <Application>Microsoft Macintosh PowerPoint</Application>
  <PresentationFormat>Panorámica</PresentationFormat>
  <Paragraphs>9</Paragraphs>
  <Slides>9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3" baseType="lpstr">
      <vt:lpstr>Aptos</vt:lpstr>
      <vt:lpstr>Aptos Display</vt:lpstr>
      <vt:lpstr>Arial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QUEL AGUDELO GUISAO</dc:creator>
  <cp:lastModifiedBy>RAQUEL AGUDELO GUISAO</cp:lastModifiedBy>
  <cp:revision>1</cp:revision>
  <dcterms:created xsi:type="dcterms:W3CDTF">2025-09-18T19:06:51Z</dcterms:created>
  <dcterms:modified xsi:type="dcterms:W3CDTF">2025-09-18T19:08:27Z</dcterms:modified>
</cp:coreProperties>
</file>